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216000" y="812520"/>
            <a:ext cx="7127280" cy="40089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56000" y="5078520"/>
            <a:ext cx="6047640" cy="481104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280680" cy="53424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278960" y="0"/>
            <a:ext cx="3280680" cy="53424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10157400"/>
            <a:ext cx="3280680" cy="53424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278960" y="10157400"/>
            <a:ext cx="3280680" cy="534240"/>
          </a:xfrm>
          <a:prstGeom prst="rect">
            <a:avLst/>
          </a:prstGeom>
        </p:spPr>
        <p:txBody>
          <a:bodyPr lIns="0" rIns="0" tIns="0" bIns="0" anchor="b"/>
          <a:p>
            <a:pPr algn="r"/>
            <a:fld id="{0D758ACA-9E61-4B8C-9175-762AA4321862}"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r>
              <a:rPr b="0" lang="en-US" sz="900" spc="-1" strike="noStrike">
                <a:latin typeface="Arial"/>
              </a:rPr>
              <a:t>Perfused VM and endothelial vessels are present in SCLC CDX. (</a:t>
            </a:r>
            <a:r>
              <a:rPr b="0" i="1" lang="en-US" sz="900" spc="-1" strike="noStrike">
                <a:latin typeface="Arial"/>
              </a:rPr>
              <a:t>A, B</a:t>
            </a:r>
            <a:r>
              <a:rPr b="0" lang="en-US" sz="900" spc="-1" strike="noStrike">
                <a:latin typeface="Arial"/>
              </a:rPr>
              <a:t>) Representative IF image of a perfused endothelial (EC) vessel (CD31</a:t>
            </a:r>
            <a:r>
              <a:rPr b="0" lang="en-US" sz="900" spc="-1" strike="noStrike" baseline="33000">
                <a:latin typeface="Arial"/>
              </a:rPr>
              <a:t>+</a:t>
            </a:r>
            <a:r>
              <a:rPr b="0" lang="en-US" sz="900" spc="-1" strike="noStrike">
                <a:latin typeface="Arial"/>
              </a:rPr>
              <a:t>/intravenous tomato lectin</a:t>
            </a:r>
            <a:r>
              <a:rPr b="0" lang="en-US" sz="900" spc="-1" strike="noStrike" baseline="33000">
                <a:latin typeface="Arial"/>
              </a:rPr>
              <a:t>+</a:t>
            </a:r>
            <a:r>
              <a:rPr b="0" lang="en-US" sz="900" spc="-1" strike="noStrike">
                <a:latin typeface="Arial"/>
              </a:rPr>
              <a:t>, yellow arrow) and a perfused VM vessel (CD31</a:t>
            </a:r>
            <a:r>
              <a:rPr b="0" lang="en-US" sz="900" spc="-1" strike="noStrike" baseline="33000">
                <a:latin typeface="Arial"/>
              </a:rPr>
              <a:t>-</a:t>
            </a:r>
            <a:r>
              <a:rPr b="0" lang="en-US" sz="900" spc="-1" strike="noStrike">
                <a:latin typeface="Arial"/>
              </a:rPr>
              <a:t>/ intravenous tomato lectin</a:t>
            </a:r>
            <a:r>
              <a:rPr b="0" lang="en-US" sz="900" spc="-1" strike="noStrike" baseline="33000">
                <a:latin typeface="Arial"/>
              </a:rPr>
              <a:t>+</a:t>
            </a:r>
            <a:r>
              <a:rPr b="0" lang="en-US" sz="900" spc="-1" strike="noStrike">
                <a:latin typeface="Arial"/>
              </a:rPr>
              <a:t>, pink arrow) within a CDX09 tumor that was harvested after intravenous tomato lectin injection. Single channel IF for CD31 (yellow) and intravenous tomato lectin (pink) illustrated with merged multiplex on the right in which nuclei are blue (DAPI stain). Scale bars 50 µm (left panel) and 10 µm (right panels). (</a:t>
            </a:r>
            <a:r>
              <a:rPr b="0" i="1" lang="en-US" sz="900" spc="-1" strike="noStrike">
                <a:latin typeface="Arial"/>
              </a:rPr>
              <a:t>C</a:t>
            </a:r>
            <a:r>
              <a:rPr b="0" lang="en-US" sz="900" spc="-1" strike="noStrike">
                <a:latin typeface="Arial"/>
              </a:rPr>
              <a:t>) Representative IF image of a perfused endothelial (EC) vessel (CD31</a:t>
            </a:r>
            <a:r>
              <a:rPr b="0" lang="en-US" sz="900" spc="-1" strike="noStrike" baseline="33000">
                <a:latin typeface="Arial"/>
              </a:rPr>
              <a:t>+</a:t>
            </a:r>
            <a:r>
              <a:rPr b="0" lang="en-US" sz="900" spc="-1" strike="noStrike">
                <a:latin typeface="Arial"/>
              </a:rPr>
              <a:t>/intravenous tomato lectin</a:t>
            </a:r>
            <a:r>
              <a:rPr b="0" lang="en-US" sz="900" spc="-1" strike="noStrike" baseline="33000">
                <a:latin typeface="Arial"/>
              </a:rPr>
              <a:t>+</a:t>
            </a:r>
            <a:r>
              <a:rPr b="0" lang="en-US" sz="900" spc="-1" strike="noStrike">
                <a:latin typeface="Arial"/>
              </a:rPr>
              <a:t>, human mitochondria</a:t>
            </a:r>
            <a:r>
              <a:rPr b="0" lang="en-US" sz="900" spc="-1" strike="noStrike" baseline="33000">
                <a:latin typeface="Arial"/>
              </a:rPr>
              <a:t>‑</a:t>
            </a:r>
            <a:r>
              <a:rPr b="0" lang="en-US" sz="900" spc="-1" strike="noStrike">
                <a:latin typeface="Arial"/>
              </a:rPr>
              <a:t>) and a perfused VM vessel (CD31</a:t>
            </a:r>
            <a:r>
              <a:rPr b="0" lang="en-US" sz="900" spc="-1" strike="noStrike" baseline="33000">
                <a:latin typeface="Arial"/>
              </a:rPr>
              <a:t>-</a:t>
            </a:r>
            <a:r>
              <a:rPr b="0" lang="en-US" sz="900" spc="-1" strike="noStrike">
                <a:latin typeface="Arial"/>
              </a:rPr>
              <a:t>/intravenous tomato lectin</a:t>
            </a:r>
            <a:r>
              <a:rPr b="0" lang="en-US" sz="900" spc="-1" strike="noStrike" baseline="33000">
                <a:latin typeface="Arial"/>
              </a:rPr>
              <a:t>+</a:t>
            </a:r>
            <a:r>
              <a:rPr b="0" lang="en-US" sz="900" spc="-1" strike="noStrike">
                <a:latin typeface="Arial"/>
              </a:rPr>
              <a:t>, human mitochondria</a:t>
            </a:r>
            <a:r>
              <a:rPr b="0" lang="en-US" sz="900" spc="-1" strike="noStrike" baseline="33000">
                <a:latin typeface="Arial"/>
              </a:rPr>
              <a:t>+</a:t>
            </a:r>
            <a:r>
              <a:rPr b="0" lang="en-US" sz="900" spc="-1" strike="noStrike">
                <a:latin typeface="Arial"/>
              </a:rPr>
              <a:t>) within a cryosectioned CDX09 tumor that was harvested after intravenous tomato lectin injection. Single channel IF for CD31 (green), intravenous tomato lectin (red) and human mitochondria (white) shown with merged multiplex on the right where CD31 and lectin overlay is yellow. Scale bars 10 µm. CDX, circulating tumor cell–derived explant; DAPI, 4',6-diamidino-2-phenylindole; EC, endothelial cell; IF, immunofluorescence; VM, vasculogenic mimicry.</a:t>
            </a:r>
            <a:endParaRPr b="0" lang="en-US" sz="900" spc="-1" strike="noStrike">
              <a:latin typeface="Arial"/>
            </a:endParaRPr>
          </a:p>
          <a:p>
            <a:endParaRPr b="0" lang="en-US" sz="900" spc="-1" strike="noStrike">
              <a:latin typeface="Arial"/>
            </a:endParaRPr>
          </a:p>
          <a:p>
            <a:endParaRPr b="0" lang="en-US" sz="900" spc="-1" strike="noStrike">
              <a:latin typeface="Arial"/>
            </a:endParaRPr>
          </a:p>
          <a:p>
            <a:endParaRPr b="0" lang="en-US" sz="9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7169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Lineage Plasticity in SCLC Generates Non-Neuroendocrine Cells Primed for Vasculogenic Mimicry</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Sarah M. Pearsall, PhD, Stuart C. Williamson, PhD, Sam Humphrey, PhD, Ellyn Hughes, PhD, Derrick Morgan, BSc, Fernando J. García Marqués, PhD, Griselda Awanis, PhD, Rebecca Carroll, MSc, Laura Burks, PhD, Yan Ting Shue, PhD, Abel Bermudez, BS, Kristopher K. Frese, PhD, Melanie Galvin, MSc, Mathew Carter, BSc, Lynsey Priest, MSc, Alastair Kerr, PhD, Cong Zhou, PhD, Trudy G. Oliver, PhD, Jonathan D. Humphries, PhD, Martin J. Humphries, PhD, Fiona Blackhall, MD, PhD, Ian G. Cannell, PhD, Sharon J. Pitteri, PhD, Gregory J. Hannon, PhD, Julien Sage, PhD, Caroline Dive, PhD, Kathryn L. Simpson, PhD</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Journal of Thoracic Oncology</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18 Issue 10 Pages 1362-1385 (Octo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jtho.2023.07.012</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3504600" y="79200"/>
            <a:ext cx="213444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Supplementary Figure 2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1830240" y="762120"/>
            <a:ext cx="5534280" cy="498420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Journal of Thoracic Oncology</a:t>
            </a:r>
            <a:r>
              <a:rPr b="0" lang="en-US" sz="900" spc="-1" strike="noStrike">
                <a:solidFill>
                  <a:srgbClr val="ffffff"/>
                </a:solidFill>
                <a:latin typeface="Arial"/>
              </a:rPr>
              <a:t> 2023 181362-1385DOI: (10.1016/j.jtho.2023.07.012)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